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02" y="6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Subtíto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ca-ES" smtClean="0"/>
              <a:t>Feu clic aquí per editar l'estil de subtítols del patró</a:t>
            </a:r>
            <a:endParaRPr lang="en-U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152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ol i text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49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ol vertical i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text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798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ol i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9929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pçalera de la sec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8291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ct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contingut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11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4" name="Contenidor de contingut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5" name="Contenidor de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6" name="Contenidor de contingut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7" name="Contenidor de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8" name="Contenidor de peu de pà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Conteni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6356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omés títo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4" name="Contenidor de peu de pà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Conteni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4660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3" name="Contenidor de peu de pà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Conteni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968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ingut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contingut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7462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tge amb l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o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'imatg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Contenidor de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ca-ES" smtClean="0"/>
              <a:t>Editeu els estils de text del patró</a:t>
            </a:r>
          </a:p>
        </p:txBody>
      </p:sp>
      <p:sp>
        <p:nvSpPr>
          <p:cNvPr id="5" name="Contenidor de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6" name="Contenidor de peu de pà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Conteni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90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idor de títo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a-ES" smtClean="0"/>
              <a:t>Feu clic aquí per editar l'estil</a:t>
            </a:r>
            <a:endParaRPr lang="en-US"/>
          </a:p>
        </p:txBody>
      </p:sp>
      <p:sp>
        <p:nvSpPr>
          <p:cNvPr id="3" name="Contenidor de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a-ES" smtClean="0"/>
              <a:t>Editeu els estils de text del patró</a:t>
            </a:r>
          </a:p>
          <a:p>
            <a:pPr lvl="1"/>
            <a:r>
              <a:rPr lang="ca-ES" smtClean="0"/>
              <a:t>Segon nivell</a:t>
            </a:r>
          </a:p>
          <a:p>
            <a:pPr lvl="2"/>
            <a:r>
              <a:rPr lang="ca-ES" smtClean="0"/>
              <a:t>Tercer nivell</a:t>
            </a:r>
          </a:p>
          <a:p>
            <a:pPr lvl="3"/>
            <a:r>
              <a:rPr lang="ca-ES" smtClean="0"/>
              <a:t>Quart nivell</a:t>
            </a:r>
          </a:p>
          <a:p>
            <a:pPr lvl="4"/>
            <a:r>
              <a:rPr lang="ca-ES" smtClean="0"/>
              <a:t>Cinquè nivell</a:t>
            </a:r>
            <a:endParaRPr lang="en-US"/>
          </a:p>
        </p:txBody>
      </p:sp>
      <p:sp>
        <p:nvSpPr>
          <p:cNvPr id="4" name="Contenidor de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D62AB9-C15B-4F01-B6F5-9B148C4723D8}" type="datetimeFigureOut">
              <a:rPr lang="en-US" smtClean="0"/>
              <a:t>6/12/2025</a:t>
            </a:fld>
            <a:endParaRPr lang="en-US"/>
          </a:p>
        </p:txBody>
      </p:sp>
      <p:sp>
        <p:nvSpPr>
          <p:cNvPr id="5" name="Contenidor de peu de pà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Conteni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E6214A-B6B7-4AA4-9F15-1404EFB3652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4249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t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52728" y="784859"/>
            <a:ext cx="6304073" cy="4784667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113903" y="1742302"/>
            <a:ext cx="5622324" cy="7784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QuadreDeText 3"/>
          <p:cNvSpPr txBox="1"/>
          <p:nvPr/>
        </p:nvSpPr>
        <p:spPr>
          <a:xfrm>
            <a:off x="827903" y="358346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04057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4995" y="635301"/>
            <a:ext cx="6950346" cy="560201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262183" y="2953264"/>
            <a:ext cx="6413157" cy="778475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QuadreDeText 5"/>
          <p:cNvSpPr txBox="1"/>
          <p:nvPr/>
        </p:nvSpPr>
        <p:spPr>
          <a:xfrm>
            <a:off x="827903" y="358346"/>
            <a:ext cx="15540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HA</a:t>
            </a:r>
          </a:p>
          <a:p>
            <a:r>
              <a:rPr lang="en-US" dirty="0" smtClean="0"/>
              <a:t>STY1 LOAD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7555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8031" y="504979"/>
            <a:ext cx="6610618" cy="5138183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854410" y="2001795"/>
            <a:ext cx="6104239" cy="6054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QuadreDeText 5"/>
          <p:cNvSpPr txBox="1"/>
          <p:nvPr/>
        </p:nvSpPr>
        <p:spPr>
          <a:xfrm>
            <a:off x="827903" y="358346"/>
            <a:ext cx="14285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SA-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85276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7070" y="553541"/>
            <a:ext cx="6795145" cy="529599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2632522" y="2898798"/>
            <a:ext cx="6104239" cy="605479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QuadreDeText 5"/>
          <p:cNvSpPr txBox="1"/>
          <p:nvPr/>
        </p:nvSpPr>
        <p:spPr>
          <a:xfrm>
            <a:off x="827903" y="358346"/>
            <a:ext cx="15540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SA-HA</a:t>
            </a:r>
          </a:p>
          <a:p>
            <a:r>
              <a:rPr lang="en-US" dirty="0" smtClean="0"/>
              <a:t>STY1 LOAD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45565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2957" y="611618"/>
            <a:ext cx="7742578" cy="549657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027404" y="2100650"/>
            <a:ext cx="6672650" cy="667264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QuadreDeText 5"/>
          <p:cNvSpPr txBox="1"/>
          <p:nvPr/>
        </p:nvSpPr>
        <p:spPr>
          <a:xfrm>
            <a:off x="827903" y="358346"/>
            <a:ext cx="14398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SD-HA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99709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tg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2739" y="715209"/>
            <a:ext cx="7424516" cy="534376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3089188" y="2953266"/>
            <a:ext cx="6536726" cy="617836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QuadreDeText 5"/>
          <p:cNvSpPr txBox="1"/>
          <p:nvPr/>
        </p:nvSpPr>
        <p:spPr>
          <a:xfrm>
            <a:off x="827903" y="358346"/>
            <a:ext cx="155401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RM1-SD-HA</a:t>
            </a:r>
          </a:p>
          <a:p>
            <a:r>
              <a:rPr lang="en-US" dirty="0" smtClean="0"/>
              <a:t>STY1 LOADING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33407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l'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</Words>
  <Application>Microsoft Office PowerPoint</Application>
  <PresentationFormat>Pantalla panoràmica</PresentationFormat>
  <Paragraphs>9</Paragraphs>
  <Slides>6</Slides>
  <Notes>0</Notes>
  <HiddenSlides>0</HiddenSlides>
  <MMClips>0</MMClips>
  <ScaleCrop>false</ScaleCrop>
  <HeadingPairs>
    <vt:vector size="6" baseType="variant">
      <vt:variant>
        <vt:lpstr>Tipus de lletra utilitzats</vt:lpstr>
      </vt:variant>
      <vt:variant>
        <vt:i4>3</vt:i4>
      </vt:variant>
      <vt:variant>
        <vt:lpstr>Tema</vt:lpstr>
      </vt:variant>
      <vt:variant>
        <vt:i4>1</vt:i4>
      </vt:variant>
      <vt:variant>
        <vt:lpstr>Títols de l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e l'Office</vt:lpstr>
      <vt:lpstr>Presentació del PowerPoint</vt:lpstr>
      <vt:lpstr>Presentació del PowerPoint</vt:lpstr>
      <vt:lpstr>Presentació del PowerPoint</vt:lpstr>
      <vt:lpstr>Presentació del PowerPoint</vt:lpstr>
      <vt:lpstr>Presentació del PowerPoint</vt:lpstr>
      <vt:lpstr>Presentació del PowerPoint</vt:lpstr>
    </vt:vector>
  </TitlesOfParts>
  <Company>Universitat Pompeu Fab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 del PowerPoint</dc:title>
  <dc:creator>u114497</dc:creator>
  <cp:lastModifiedBy>u114497</cp:lastModifiedBy>
  <cp:revision>2</cp:revision>
  <dcterms:created xsi:type="dcterms:W3CDTF">2025-06-12T15:33:22Z</dcterms:created>
  <dcterms:modified xsi:type="dcterms:W3CDTF">2025-06-12T15:36:29Z</dcterms:modified>
</cp:coreProperties>
</file>